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C6B5BC-B57F-4A8C-9BC2-8E38855BAA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3F980D-87BF-43A6-90AF-75680B10CF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29C18-5E13-4E1B-B17B-59C5D5B5E8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A1A9A-2CA2-40F5-A320-7C91FC19CB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AEDA1-5D58-4E74-8917-7DEF8C1A89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6BD5C-6DE0-4C9A-888A-42EF78480B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A96A3-8C66-4E9C-BB4F-93F496047B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60DE5-A3C7-4C5B-9D81-CC68368FDF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603F9-FA67-4FFB-9708-F8C52A53C9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CA216-C9E6-4A30-8D03-5D3AC873E4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8AA37D-EF78-4F70-9F09-A6C6D84A3D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94FBC-92A0-489A-AA4B-ED4A8EC6D8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71D42B-29A2-4298-A59D-19E599B6B741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1360" y="5952960"/>
            <a:ext cx="878544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Additional data file 3 - Interaction subnetworks for gene products whose disruption causes Ni specific sensi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Both co-sensitive mutants (shown in smaller characters and specified in Fig. 2) as well as Ni-specific sensitive mutants (shown in larger characters) were utilized to build these networks. Previously identified subnetworks expanded with respect to Ni/Cd co-sensitive mutants (Fig. 2) and newly identified, Ni-specific subnetworks are encircled in red and blue, respectively. Symbols and colour codes are as described in Fig. 2 legen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85840" y="260280"/>
            <a:ext cx="8543880" cy="5540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07T09:19:32Z</dcterms:created>
  <dc:creator>Roberta</dc:creator>
  <dc:description/>
  <dc:language>en-US</dc:language>
  <cp:lastModifiedBy>Dipartimento di Biochimica e Biologia Molecolare</cp:lastModifiedBy>
  <dcterms:modified xsi:type="dcterms:W3CDTF">2008-04-04T15:07:20Z</dcterms:modified>
  <cp:revision>23</cp:revision>
  <dc:subject/>
  <dc:title>Diapositiva 1</dc:title>
</cp:coreProperties>
</file>